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0" r:id="rId3"/>
    <p:sldId id="264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5" d="100"/>
          <a:sy n="35" d="100"/>
        </p:scale>
        <p:origin x="45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C526CF-2D2C-DC50-52FF-FF6C8A0896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5A4F60B-8042-8D60-FE6A-3BE5C74D49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7C73AF-331F-D728-3F71-364726412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D5F3FA-5E33-15D6-2E3C-F3807889C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D4549B-200B-4E76-2B4C-C467F5F07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5639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FF21F1-51BC-6451-7C54-BF2E440A8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BF90575-5A09-3463-DE4D-CF20A15ECB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94FE0A-BF72-58C5-7C4C-BB251F893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3642E0-3395-752D-BC6C-7DBF276B3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A74AD0-1781-C866-D302-B4135F0A3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17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DD62AA-4629-C288-C124-26F5159EA7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1B0E595-B528-F4C3-CD7D-D9CD5DB597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CA5C5D-CA28-8A25-DA45-C4D0EBE92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52119F8-2CC3-BDE9-3832-E002CE485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A0F09A-A315-6565-E010-EE71821F6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2383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EF62D4-1C4A-BAAA-B40D-9545C9F7F5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09FB43-554D-3BD5-86A3-09247BBF3B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7C5E5C-7433-A2DD-1588-7C3836041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42B8D0-A6FF-B815-2ECC-8A8EE17B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C32D0-F7F8-4709-265E-5CA9C8FBC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0124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7F2EF6-C4D2-9336-F540-655AF8E2CC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BD9A38-26D5-E26A-B082-EBF823F021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0B081F-D789-ED32-4E2C-8386B9CBA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9945C7-7506-3C7F-DED7-A2149FB9D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B46556-2F5E-EB5E-FF94-97A91BA30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6503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C25296-13AA-95DA-7E62-3081C83CA6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224FBA-E5DD-A93C-C1EE-58395EE5BC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49AC0B6-85D6-16BB-03FA-23A8EE3FDF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2F0441-973D-DC8C-1EBF-F350AA434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C0055-3A79-76E2-557D-284BE9462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8F9FF2-1038-F0ED-A152-8293A9EBC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5119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D6B689-7F0B-6C78-AAF1-C7769BA9D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75DD26-CAC8-0D44-9C47-0961080A94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580969-151A-80FD-18AB-EA298F432E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4EA130B-3729-E564-E6F6-AF07E4D663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79DC867-9761-6803-05B1-1A1245F09C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BC7A99D-5FB2-2F77-94DB-A89D75B30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26774BC-9169-CA25-2501-619877DA0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837FA4F-052E-ABDF-33C6-55A9BB5AC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874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7ADA7B-2F23-B7BB-A6B9-40956AE240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2DC3FE2-1E9B-ECA6-58E5-C9F5A03C6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EAA97F1-C3F4-7DFC-C34A-6E9045F19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B006A4D-E3F8-4485-4118-620E033B8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935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130A0A0-0955-17EF-2A4F-EC93129D0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E633C8C-9446-0366-E407-9193D36F6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5661B06-A069-63D1-4810-E5AC2C5ED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5009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304515-D26B-C7ED-AEAC-926A90517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3E6E73A-CB1D-0614-5D85-3E3D490DB7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5944675-9DAE-2081-B5D4-1695AB1F7D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60564B-9611-0691-9698-06B9C8E62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EC28DF5-E38D-754D-EAED-9540C10A6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7B6CE4-1B37-BE20-9D64-42606D5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960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3345E4-6AFC-3D53-CD06-CB70584363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BB67563-8D62-4B2D-B2C2-ADF0D1EC30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F65B659-F8D4-816E-AE6F-42D5602E9D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573CF7-0376-349C-9FAF-4B2BD2AAA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5BF6EF1-DBB1-5117-F289-FA7DB4170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950A8F-F7BD-E7B2-0664-EE0B20439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4544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DD24C5-B36A-4B04-80D9-77913EC2D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105FA79-DBEC-3439-FB31-6A91C241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2C318A-34F8-B09B-857B-C98FB8BCFA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C0045-47D5-468D-B502-92CADA83E41D}" type="datetimeFigureOut">
              <a:rPr lang="zh-CN" altLang="en-US" smtClean="0"/>
              <a:t>2023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9D9412-AA23-7DD8-AE63-3F7DD27A17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515C7B-3E59-C182-B3FE-23AF239D8A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34666-C06A-446B-8EC5-8CF211872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263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E2A09EE-3F19-69C9-CEF7-9FACEA47128D}"/>
              </a:ext>
            </a:extLst>
          </p:cNvPr>
          <p:cNvSpPr txBox="1"/>
          <p:nvPr/>
        </p:nvSpPr>
        <p:spPr>
          <a:xfrm>
            <a:off x="3095625" y="5680358"/>
            <a:ext cx="60007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1 </a:t>
            </a:r>
            <a:r>
              <a:rPr lang="en-US" sz="1800" kern="100" dirty="0">
                <a:effectLst/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rPr>
              <a:t>Continuous calibration curve illustrating the predictive capability of the summary model</a:t>
            </a:r>
            <a:endParaRPr lang="en-GB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5FC644D3-634D-128D-373C-622C756FC0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5039" y="500110"/>
            <a:ext cx="6909435" cy="5180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5500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C308FB0-C7B3-C96D-D83C-4D7C613D47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2157" y="0"/>
            <a:ext cx="7769543" cy="582510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E2A09EE-3F19-69C9-CEF7-9FACEA47128D}"/>
              </a:ext>
            </a:extLst>
          </p:cNvPr>
          <p:cNvSpPr txBox="1"/>
          <p:nvPr/>
        </p:nvSpPr>
        <p:spPr>
          <a:xfrm>
            <a:off x="676275" y="5406700"/>
            <a:ext cx="113347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2 </a:t>
            </a:r>
            <a:r>
              <a:rPr lang="en-US" sz="1800" kern="100" dirty="0">
                <a:effectLst/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rPr>
              <a:t>Decision Curve Analysis (DCA) curves comparing the Summary model with other models, demonstrating net benefit across different probability thresholds</a:t>
            </a:r>
            <a:endParaRPr lang="en-GB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82245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E2A09EE-3F19-69C9-CEF7-9FACEA47128D}"/>
              </a:ext>
            </a:extLst>
          </p:cNvPr>
          <p:cNvSpPr txBox="1"/>
          <p:nvPr/>
        </p:nvSpPr>
        <p:spPr>
          <a:xfrm>
            <a:off x="2750148" y="5553075"/>
            <a:ext cx="66484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3 </a:t>
            </a:r>
            <a:r>
              <a:rPr lang="en-US" sz="1800" dirty="0">
                <a:effectLst/>
                <a:latin typeface="DengXian" panose="02010600030101010101" pitchFamily="2" charset="-122"/>
                <a:cs typeface="Times New Roman" panose="02020603050405020304" pitchFamily="18" charset="0"/>
              </a:rPr>
              <a:t>Continuous calibration curve illustrating the predictive capability in the validation set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0595708-E251-D17B-A8FA-451A9E3810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0148" y="536067"/>
            <a:ext cx="6691704" cy="5017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7081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ng</dc:creator>
  <cp:lastModifiedBy>Samson Oyebanjo</cp:lastModifiedBy>
  <cp:revision>10</cp:revision>
  <dcterms:created xsi:type="dcterms:W3CDTF">2023-06-26T14:46:50Z</dcterms:created>
  <dcterms:modified xsi:type="dcterms:W3CDTF">2023-10-27T08:19:47Z</dcterms:modified>
</cp:coreProperties>
</file>